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9" r:id="rId2"/>
    <p:sldId id="337" r:id="rId3"/>
    <p:sldId id="331" r:id="rId4"/>
    <p:sldId id="332" r:id="rId5"/>
    <p:sldId id="336" r:id="rId6"/>
    <p:sldId id="32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40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0BE89D-AA69-49EE-A9A3-C48A3EA65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7D6162-506A-4E11-BD69-02541FD52D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6DC7CF-F9B3-426A-9E9A-A11823696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644258-6D4E-44AA-BECE-B78FC4C9A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A206A2-8F84-499A-9D6A-BE6908D0C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8787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C9C14-4C24-4EE5-BC15-4FD68CC04C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0865D4-5AE4-4C0B-A2ED-A7A3CD2C84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0E9926-7E80-4E73-8CFD-D45692714F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68D5E8-365B-4226-922F-3BC740394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1492B1-121D-4551-A09E-631D80B05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93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EAE34E-B1EC-4D83-AC39-91EB4C48A8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089DF3-E1C5-4DE6-9771-21DD556563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F441BD-449A-4CA5-A1B6-64E5DB280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D3FBBF-573D-4FAB-8840-9A84F4695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BB45C6-057A-491B-A2D5-505D9602F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7596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2463E-25E7-4B6B-B209-E29D5B7EBA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70BFFB-ACFC-4784-9DDA-3748B61516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A04DBA-8C3D-427E-A2A0-AFD3ABCF17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9CCD29-5C51-45DD-9DDD-416EFCF9E2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745010-6D9D-491E-9A5A-099ECF1CF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129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D232D0-E93C-447B-9EE1-4AA4A03417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A8D6B8-39D3-4F62-BBA4-BF3AFDB471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882B7C-5C00-48BD-9652-D4251F11F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B58229-9569-44E8-BA7E-FB7A517293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5B6EF0-610D-4DE2-9ABC-1FA8FC74B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352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015D6-1728-4C47-81E3-851C4340B1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FEC42B-5C7B-42DF-A69D-956F775696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99CD9-BAA3-4E07-9EF0-5A11140EDD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CD867D-0FCE-4943-8E5E-16C130E49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ABAFE1-0430-431A-A599-C60B33324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CC81C7-7F9E-468F-A6CF-04D768C13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830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B62D1-89DA-4400-AB96-CEACF7E99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D0D5F3-D126-490B-8BD7-6B554EBAC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046EBD-DD1C-432D-99B0-516B93073F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D9C7385-5206-4A4E-8C88-ED66314D57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FA2C81-691F-4418-BF11-580D7709D9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A49A37-27FF-4BC9-AF4D-17D563261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57076F-6663-4758-991D-C46B0782F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E9F6C8-D59A-4DBE-AD8A-A5DEA207F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627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0F5A75-31ED-4037-82E3-8304994FAE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BBAAB71-C9A7-4618-A574-BDE7F198A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5466C5-7748-4189-8E31-3901AA7E8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E4C28CF-71FB-4C94-A185-C20B2A93B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217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FAC529-627B-40CF-BB1B-570AD7BD7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1A5179E-1681-477C-A115-BBDC4905F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7A7D6D-0E0D-4BAB-8A1B-37D125A64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5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D51895-1644-4DDC-A2F4-1229C22BE1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E0AADB-F2A6-468C-9E8F-814375DFA2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EC09AD-F613-4054-A7F0-48E1156370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80847E-4EEA-438A-9472-707F2DD51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626914-746D-4ED5-BD0A-0DEC9D7643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A9BCF9-0B90-435C-A1BD-553929BA50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176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5E8A6D-D70B-412F-BCC1-916B5359C8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312573D-F771-4439-830F-6E3BFAB9564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5C590A-E880-450C-8D73-06EAB99564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8E9A8C-1860-4D29-BEA7-BA3C21921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1E5AEF-CBD3-4CA5-9505-2A6DCA596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0D155D-D37E-416E-9E80-3140C146CB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066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4674EC3-0EEB-4E61-860F-6956BE5075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733B9D-6D4C-4303-89B8-FAED17A026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A9EDA4-9875-4283-8914-4B8F4DFC0E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5D476-1993-454E-B52C-83DBC7AFF1F0}" type="datetimeFigureOut">
              <a:rPr lang="en-US" smtClean="0"/>
              <a:t>3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6D4E3A-5EFE-41B3-997C-BE55F43E0C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796AF2-7600-4988-9CA6-1B2215A6C4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A739D-FEC1-4071-9698-E1CEF5817F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8246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267200" y="1560136"/>
            <a:ext cx="3657600" cy="3138864"/>
            <a:chOff x="4267200" y="1560136"/>
            <a:chExt cx="3657600" cy="3138864"/>
          </a:xfrm>
        </p:grpSpPr>
        <p:sp>
          <p:nvSpPr>
            <p:cNvPr id="3" name="TextBox 2"/>
            <p:cNvSpPr txBox="1"/>
            <p:nvPr/>
          </p:nvSpPr>
          <p:spPr>
            <a:xfrm>
              <a:off x="4477732" y="1560136"/>
              <a:ext cx="33698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Supplemental </a:t>
              </a:r>
              <a:r>
                <a:rPr lang="en-US" sz="2400">
                  <a:latin typeface="Arial" panose="020B0604020202020204" pitchFamily="34" charset="0"/>
                  <a:cs typeface="Arial" panose="020B0604020202020204" pitchFamily="34" charset="0"/>
                </a:rPr>
                <a:t>Figure 1</a:t>
              </a:r>
              <a:endParaRPr 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Group 49"/>
            <p:cNvGrpSpPr/>
            <p:nvPr/>
          </p:nvGrpSpPr>
          <p:grpSpPr>
            <a:xfrm>
              <a:off x="4267200" y="2159000"/>
              <a:ext cx="3657600" cy="2540000"/>
              <a:chOff x="4267200" y="2159000"/>
              <a:chExt cx="3657600" cy="2540000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E9939B50-7624-2743-8188-76C18900821B}"/>
                  </a:ext>
                </a:extLst>
              </p:cNvPr>
              <p:cNvSpPr txBox="1"/>
              <p:nvPr/>
            </p:nvSpPr>
            <p:spPr>
              <a:xfrm>
                <a:off x="6640436" y="3429000"/>
                <a:ext cx="128436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US" sz="16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=0.925</a:t>
                </a:r>
              </a:p>
            </p:txBody>
          </p:sp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932ADF16-F4F0-5940-9FCC-DE9A04985B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267200" y="2159000"/>
                <a:ext cx="3657600" cy="25400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656792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65FE8A9E-0F53-48E9-920E-C65516E464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778" y="570187"/>
            <a:ext cx="7800546" cy="62074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224F5FB-DC29-48D4-A1DC-1E56D2684C18}"/>
              </a:ext>
            </a:extLst>
          </p:cNvPr>
          <p:cNvSpPr txBox="1"/>
          <p:nvPr/>
        </p:nvSpPr>
        <p:spPr>
          <a:xfrm>
            <a:off x="4146586" y="80376"/>
            <a:ext cx="34033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11212826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487ED5-B9A1-DF48-B531-4AB61D5C7364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3755032" y="1391370"/>
            <a:ext cx="3302756" cy="536575"/>
          </a:xfrm>
        </p:spPr>
        <p:txBody>
          <a:bodyPr>
            <a:no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3327663" y="1911982"/>
            <a:ext cx="4623848" cy="3916670"/>
            <a:chOff x="3256962" y="1687400"/>
            <a:chExt cx="4623848" cy="3916670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48DA8D3-C386-EE47-A918-2F4D31EAA4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56962" y="1687400"/>
              <a:ext cx="4623848" cy="3916670"/>
            </a:xfrm>
            <a:prstGeom prst="rect">
              <a:avLst/>
            </a:prstGeom>
          </p:spPr>
        </p:pic>
        <p:cxnSp>
          <p:nvCxnSpPr>
            <p:cNvPr id="12" name="Straight Connector 11"/>
            <p:cNvCxnSpPr/>
            <p:nvPr/>
          </p:nvCxnSpPr>
          <p:spPr>
            <a:xfrm>
              <a:off x="4661556" y="2135174"/>
              <a:ext cx="1814660" cy="141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H="1">
              <a:off x="4670989" y="2122596"/>
              <a:ext cx="1570" cy="64008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H="1">
              <a:off x="6468358" y="2138311"/>
              <a:ext cx="1570" cy="10058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5096641" y="1758097"/>
              <a:ext cx="827471" cy="3694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1" dirty="0"/>
                <a:t>P&lt;0.0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883642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Connector 8"/>
          <p:cNvCxnSpPr/>
          <p:nvPr/>
        </p:nvCxnSpPr>
        <p:spPr>
          <a:xfrm>
            <a:off x="4331616" y="1831311"/>
            <a:ext cx="1097280" cy="141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>
            <a:off x="5417270" y="1837590"/>
            <a:ext cx="1570" cy="1828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4319044" y="1823452"/>
            <a:ext cx="1570" cy="8229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361233" y="1559570"/>
            <a:ext cx="944489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dirty="0"/>
              <a:t>P=0.067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2975320" y="1127815"/>
            <a:ext cx="3303810" cy="3719834"/>
            <a:chOff x="2989460" y="1141955"/>
            <a:chExt cx="3303810" cy="3719834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DD7F73E-7ECB-3B45-8D3B-310173AA80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-2243" t="10230" r="1"/>
            <a:stretch/>
          </p:blipFill>
          <p:spPr>
            <a:xfrm>
              <a:off x="3063711" y="1418734"/>
              <a:ext cx="3155308" cy="3443055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2989460" y="1141955"/>
              <a:ext cx="330381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Supplemental Figure 4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746175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683BA61-47A3-4E8D-BEC7-556029F0E43C}"/>
              </a:ext>
            </a:extLst>
          </p:cNvPr>
          <p:cNvSpPr txBox="1"/>
          <p:nvPr/>
        </p:nvSpPr>
        <p:spPr>
          <a:xfrm>
            <a:off x="1911927" y="865500"/>
            <a:ext cx="33202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  <a:endParaRPr lang="en-US" sz="24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FCBCD6-A647-4C36-AD93-D401368987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179" y="2156907"/>
            <a:ext cx="5599438" cy="32918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35D2B7F-FE44-442D-A1B3-EBAA6A6D9B2A}"/>
              </a:ext>
            </a:extLst>
          </p:cNvPr>
          <p:cNvSpPr txBox="1"/>
          <p:nvPr/>
        </p:nvSpPr>
        <p:spPr>
          <a:xfrm>
            <a:off x="813613" y="2156907"/>
            <a:ext cx="3178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075A271A-57B5-4D0B-9207-FB82C5839BC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9550" y="2156907"/>
            <a:ext cx="4525037" cy="32918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665B962-A362-44FB-A9DD-64E6030E2FE2}"/>
              </a:ext>
            </a:extLst>
          </p:cNvPr>
          <p:cNvSpPr txBox="1"/>
          <p:nvPr/>
        </p:nvSpPr>
        <p:spPr>
          <a:xfrm>
            <a:off x="6789759" y="2147942"/>
            <a:ext cx="3178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35115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84843" y="209465"/>
            <a:ext cx="32602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6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3426" y="671130"/>
            <a:ext cx="7453290" cy="55157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9746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</Words>
  <Application>Microsoft Office PowerPoint</Application>
  <PresentationFormat>Widescreen</PresentationFormat>
  <Paragraphs>11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Supplemental Figure 3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shbein, Ilia</dc:creator>
  <cp:lastModifiedBy>Fishbein, Ilia</cp:lastModifiedBy>
  <cp:revision>2</cp:revision>
  <dcterms:created xsi:type="dcterms:W3CDTF">2021-12-20T13:49:03Z</dcterms:created>
  <dcterms:modified xsi:type="dcterms:W3CDTF">2022-03-04T20:41:18Z</dcterms:modified>
</cp:coreProperties>
</file>